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463" autoAdjust="0"/>
    <p:restoredTop sz="94660"/>
  </p:normalViewPr>
  <p:slideViewPr>
    <p:cSldViewPr snapToGrid="0">
      <p:cViewPr varScale="1">
        <p:scale>
          <a:sx n="78" d="100"/>
          <a:sy n="78" d="100"/>
        </p:scale>
        <p:origin x="50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9/03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tiff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286862" y="0"/>
            <a:ext cx="9946797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47500" lnSpcReduction="2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lnSpc>
                <a:spcPct val="120000"/>
              </a:lnSpc>
            </a:pPr>
            <a:r>
              <a:rPr lang="tr-TR" b="1" dirty="0">
                <a:solidFill>
                  <a:schemeClr val="bg1"/>
                </a:solidFill>
              </a:rPr>
              <a:t>Survival of paediatric dialysis patients in Türkiye over a three-year follow</a:t>
            </a:r>
            <a:r>
              <a:rPr lang="en-GB" b="1" dirty="0">
                <a:solidFill>
                  <a:schemeClr val="bg1"/>
                </a:solidFill>
              </a:rPr>
              <a:t>-</a:t>
            </a:r>
            <a:r>
              <a:rPr lang="tr-TR" b="1" dirty="0">
                <a:solidFill>
                  <a:schemeClr val="bg1"/>
                </a:solidFill>
              </a:rPr>
              <a:t>up: </a:t>
            </a:r>
            <a:r>
              <a:rPr lang="en-GB" b="1" dirty="0">
                <a:solidFill>
                  <a:schemeClr val="bg1"/>
                </a:solidFill>
              </a:rPr>
              <a:t>f</a:t>
            </a:r>
            <a:r>
              <a:rPr lang="tr-TR" b="1" dirty="0">
                <a:solidFill>
                  <a:schemeClr val="bg1"/>
                </a:solidFill>
              </a:rPr>
              <a:t>indings from national database</a:t>
            </a:r>
            <a:endParaRPr lang="tr-TR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86863" y="1046874"/>
            <a:ext cx="1190513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solidFill>
                  <a:schemeClr val="bg1"/>
                </a:solidFill>
              </a:rPr>
              <a:t>AIM</a:t>
            </a:r>
            <a:r>
              <a:rPr lang="en-GB" sz="1600" dirty="0">
                <a:solidFill>
                  <a:schemeClr val="bg1"/>
                </a:solidFill>
              </a:rPr>
              <a:t>: </a:t>
            </a:r>
            <a:r>
              <a:rPr lang="en-US" sz="1600" dirty="0">
                <a:solidFill>
                  <a:schemeClr val="bg1"/>
                </a:solidFill>
              </a:rPr>
              <a:t>Focus on the study was to compare the </a:t>
            </a:r>
            <a:r>
              <a:rPr lang="tr-TR" sz="1600" dirty="0">
                <a:solidFill>
                  <a:schemeClr val="bg1"/>
                </a:solidFill>
              </a:rPr>
              <a:t>3</a:t>
            </a:r>
            <a:r>
              <a:rPr lang="en-US" sz="1600" dirty="0">
                <a:solidFill>
                  <a:schemeClr val="bg1"/>
                </a:solidFill>
              </a:rPr>
              <a:t>-year survival rates of children and adolescents undergoing peritoneal dialysis (PD) and hemodialysis (HD) using national data.</a:t>
            </a:r>
            <a:endParaRPr lang="en-GB" sz="1600" dirty="0">
              <a:solidFill>
                <a:schemeClr val="bg1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2000" b="1" dirty="0">
                <a:solidFill>
                  <a:schemeClr val="bg1"/>
                </a:solidFill>
                <a:latin typeface="+mj-lt"/>
              </a:rPr>
              <a:t>Kaya Aksoy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6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86862" y="5817167"/>
            <a:ext cx="727402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8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tr-TR" dirty="0" err="1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Peritoneal</a:t>
            </a:r>
            <a:r>
              <a:rPr lang="tr-TR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dirty="0" err="1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dialysis</a:t>
            </a:r>
            <a:r>
              <a:rPr lang="tr-TR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has </a:t>
            </a:r>
            <a:r>
              <a:rPr lang="tr-TR" dirty="0" err="1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been</a:t>
            </a:r>
            <a:r>
              <a:rPr lang="tr-TR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dirty="0" err="1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hown</a:t>
            </a:r>
            <a:r>
              <a:rPr lang="tr-TR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dirty="0" err="1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o</a:t>
            </a:r>
            <a:r>
              <a:rPr lang="tr-TR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be </a:t>
            </a:r>
            <a:r>
              <a:rPr lang="tr-TR" dirty="0" err="1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ssociated</a:t>
            </a:r>
            <a:r>
              <a:rPr lang="tr-TR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dirty="0" err="1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with</a:t>
            </a:r>
            <a:r>
              <a:rPr lang="tr-TR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dirty="0" err="1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better</a:t>
            </a:r>
            <a:r>
              <a:rPr lang="tr-TR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dirty="0" err="1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urvival</a:t>
            </a:r>
            <a:r>
              <a:rPr lang="tr-TR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dirty="0" err="1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rates</a:t>
            </a:r>
            <a:r>
              <a:rPr lang="tr-TR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dirty="0" err="1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han</a:t>
            </a:r>
            <a:r>
              <a:rPr lang="tr-TR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dirty="0" err="1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haemodialysis</a:t>
            </a:r>
            <a:r>
              <a:rPr lang="tr-TR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in </a:t>
            </a:r>
            <a:r>
              <a:rPr lang="tr-TR" dirty="0" err="1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hildren</a:t>
            </a:r>
            <a:r>
              <a:rPr lang="tr-TR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dirty="0" err="1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with</a:t>
            </a:r>
            <a:r>
              <a:rPr lang="tr-TR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dirty="0" err="1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tage</a:t>
            </a:r>
            <a:r>
              <a:rPr lang="tr-TR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5 CKD, </a:t>
            </a:r>
            <a:r>
              <a:rPr lang="tr-TR" dirty="0" err="1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particularly</a:t>
            </a:r>
            <a:r>
              <a:rPr lang="tr-TR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dirty="0" err="1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mong</a:t>
            </a:r>
            <a:r>
              <a:rPr lang="tr-TR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dirty="0" err="1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younger</a:t>
            </a:r>
            <a:r>
              <a:rPr lang="tr-TR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dirty="0" err="1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patients</a:t>
            </a:r>
            <a:r>
              <a:rPr lang="tr-TR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endParaRPr lang="en-TR" dirty="0">
              <a:solidFill>
                <a:schemeClr val="bg1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object 5"/>
          <p:cNvSpPr txBox="1"/>
          <p:nvPr/>
        </p:nvSpPr>
        <p:spPr>
          <a:xfrm>
            <a:off x="672037" y="1662323"/>
            <a:ext cx="1325975" cy="320601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2000" b="1" spc="-10" dirty="0">
                <a:solidFill>
                  <a:srgbClr val="231F20"/>
                </a:solidFill>
                <a:cs typeface="CaeciliaLTPro-75Bold"/>
              </a:rPr>
              <a:t>Methods</a:t>
            </a:r>
            <a:endParaRPr sz="2000" b="1" dirty="0">
              <a:cs typeface="CaeciliaLTPro-75Bold"/>
            </a:endParaRPr>
          </a:p>
        </p:txBody>
      </p:sp>
      <p:pic>
        <p:nvPicPr>
          <p:cNvPr id="9" name="Picture 18" descr="https://icons.biorender.com/w75xh75/641871b7a509830020037679/spreadsheet-symbol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664" y="2156859"/>
            <a:ext cx="954978" cy="9805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Metin kutusu 9"/>
          <p:cNvSpPr txBox="1"/>
          <p:nvPr/>
        </p:nvSpPr>
        <p:spPr>
          <a:xfrm>
            <a:off x="73485" y="3192910"/>
            <a:ext cx="2242493" cy="22797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lnSpc>
                <a:spcPct val="150000"/>
              </a:lnSpc>
              <a:buFontTx/>
              <a:buChar char="-"/>
            </a:pPr>
            <a:r>
              <a:rPr lang="tr-TR" sz="1400" dirty="0" err="1"/>
              <a:t>Between</a:t>
            </a:r>
            <a:r>
              <a:rPr lang="tr-TR" sz="1400" dirty="0"/>
              <a:t> 2006 </a:t>
            </a:r>
            <a:r>
              <a:rPr lang="tr-TR" sz="1400" dirty="0" err="1"/>
              <a:t>and</a:t>
            </a:r>
            <a:r>
              <a:rPr lang="tr-TR" sz="1400" dirty="0"/>
              <a:t> 2022</a:t>
            </a:r>
          </a:p>
          <a:p>
            <a:pPr marL="171450" indent="-171450">
              <a:lnSpc>
                <a:spcPct val="150000"/>
              </a:lnSpc>
              <a:buFontTx/>
              <a:buChar char="-"/>
            </a:pPr>
            <a:r>
              <a:rPr lang="tr-TR" sz="1400" dirty="0"/>
              <a:t>O</a:t>
            </a:r>
            <a:r>
              <a:rPr lang="en-US" sz="1400" dirty="0" err="1"/>
              <a:t>btained</a:t>
            </a:r>
            <a:r>
              <a:rPr lang="en-US" sz="1400" dirty="0"/>
              <a:t> from the national database</a:t>
            </a:r>
            <a:endParaRPr lang="tr-TR" sz="1400" dirty="0"/>
          </a:p>
          <a:p>
            <a:pPr marL="171450" indent="-171450">
              <a:lnSpc>
                <a:spcPct val="150000"/>
              </a:lnSpc>
              <a:buFontTx/>
              <a:buChar char="-"/>
            </a:pPr>
            <a:r>
              <a:rPr lang="en-US" sz="1400" dirty="0"/>
              <a:t>Patients &lt;18 years of age</a:t>
            </a:r>
            <a:endParaRPr lang="tr-TR" sz="1400" dirty="0"/>
          </a:p>
          <a:p>
            <a:pPr marL="171450" indent="-171450">
              <a:lnSpc>
                <a:spcPct val="150000"/>
              </a:lnSpc>
              <a:buFontTx/>
              <a:buChar char="-"/>
            </a:pPr>
            <a:r>
              <a:rPr lang="tr-TR" sz="1400" dirty="0"/>
              <a:t>W</a:t>
            </a:r>
            <a:r>
              <a:rPr lang="en-US" sz="1400" dirty="0" err="1"/>
              <a:t>ith</a:t>
            </a:r>
            <a:r>
              <a:rPr lang="en-US" sz="1400" dirty="0"/>
              <a:t> at least 3 months of follow-up</a:t>
            </a:r>
            <a:endParaRPr lang="tr-TR" sz="1400" dirty="0"/>
          </a:p>
          <a:p>
            <a:pPr marL="171450" indent="-171450">
              <a:lnSpc>
                <a:spcPct val="150000"/>
              </a:lnSpc>
              <a:buFontTx/>
              <a:buChar char="-"/>
            </a:pPr>
            <a:endParaRPr lang="tr-TR" sz="1200" dirty="0">
              <a:latin typeface="CaeciliaLTPro-75Bold"/>
            </a:endParaRPr>
          </a:p>
        </p:txBody>
      </p:sp>
      <p:sp>
        <p:nvSpPr>
          <p:cNvPr id="11" name="object 7"/>
          <p:cNvSpPr txBox="1"/>
          <p:nvPr/>
        </p:nvSpPr>
        <p:spPr>
          <a:xfrm>
            <a:off x="3562866" y="1663747"/>
            <a:ext cx="1553964" cy="320601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algn="ctr">
              <a:lnSpc>
                <a:spcPct val="100000"/>
              </a:lnSpc>
              <a:spcBef>
                <a:spcPts val="100"/>
              </a:spcBef>
            </a:pPr>
            <a:r>
              <a:rPr sz="2000" b="1" spc="-10" dirty="0">
                <a:cs typeface="CaeciliaLTPro-75Bold"/>
              </a:rPr>
              <a:t>Results</a:t>
            </a:r>
            <a:endParaRPr sz="2000" b="1" dirty="0">
              <a:cs typeface="CaeciliaLTPro-75Bold"/>
            </a:endParaRPr>
          </a:p>
        </p:txBody>
      </p:sp>
      <p:sp>
        <p:nvSpPr>
          <p:cNvPr id="12" name="Metin kutusu 11"/>
          <p:cNvSpPr txBox="1"/>
          <p:nvPr/>
        </p:nvSpPr>
        <p:spPr>
          <a:xfrm>
            <a:off x="2287534" y="2038085"/>
            <a:ext cx="4468058" cy="1569660"/>
          </a:xfrm>
          <a:prstGeom prst="rect">
            <a:avLst/>
          </a:prstGeom>
          <a:noFill/>
          <a:ln w="12700"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tr-TR" sz="1600" b="1" dirty="0"/>
              <a:t>                </a:t>
            </a:r>
            <a:r>
              <a:rPr lang="tr-TR" sz="1600" dirty="0"/>
              <a:t>n=935 (420 PD </a:t>
            </a:r>
            <a:r>
              <a:rPr lang="tr-TR" sz="1600" dirty="0" err="1"/>
              <a:t>and</a:t>
            </a:r>
            <a:r>
              <a:rPr lang="tr-TR" sz="1600" dirty="0"/>
              <a:t> 515 HD)</a:t>
            </a:r>
          </a:p>
          <a:p>
            <a:endParaRPr lang="en-TR" sz="1600" dirty="0"/>
          </a:p>
          <a:p>
            <a:r>
              <a:rPr lang="tr-TR" sz="1600" dirty="0"/>
              <a:t>                </a:t>
            </a:r>
            <a:r>
              <a:rPr lang="tr-TR" sz="1600" dirty="0" err="1"/>
              <a:t>Median</a:t>
            </a:r>
            <a:r>
              <a:rPr lang="tr-TR" sz="1600" dirty="0"/>
              <a:t> </a:t>
            </a:r>
            <a:r>
              <a:rPr lang="tr-TR" sz="1600" dirty="0" err="1">
                <a:effectLst/>
                <a:ea typeface="Calibri" panose="020F0502020204030204" pitchFamily="34" charset="0"/>
              </a:rPr>
              <a:t>age</a:t>
            </a:r>
            <a:r>
              <a:rPr lang="tr-TR" sz="1600" dirty="0">
                <a:effectLst/>
                <a:ea typeface="Calibri" panose="020F0502020204030204" pitchFamily="34" charset="0"/>
              </a:rPr>
              <a:t> at </a:t>
            </a:r>
            <a:r>
              <a:rPr lang="tr-TR" sz="1600" dirty="0" err="1">
                <a:effectLst/>
                <a:ea typeface="Calibri" panose="020F0502020204030204" pitchFamily="34" charset="0"/>
              </a:rPr>
              <a:t>dialysis</a:t>
            </a:r>
            <a:r>
              <a:rPr lang="tr-TR" sz="1600" dirty="0">
                <a:effectLst/>
                <a:ea typeface="Calibri" panose="020F0502020204030204" pitchFamily="34" charset="0"/>
              </a:rPr>
              <a:t> </a:t>
            </a:r>
            <a:r>
              <a:rPr lang="tr-TR" sz="1600" dirty="0" err="1">
                <a:effectLst/>
                <a:ea typeface="Calibri" panose="020F0502020204030204" pitchFamily="34" charset="0"/>
              </a:rPr>
              <a:t>initiation</a:t>
            </a:r>
            <a:r>
              <a:rPr lang="tr-TR" sz="1600" dirty="0">
                <a:effectLst/>
                <a:ea typeface="Calibri" panose="020F0502020204030204" pitchFamily="34" charset="0"/>
              </a:rPr>
              <a:t> </a:t>
            </a:r>
            <a:r>
              <a:rPr lang="tr-TR" sz="1600" dirty="0" err="1">
                <a:effectLst/>
                <a:ea typeface="Calibri" panose="020F0502020204030204" pitchFamily="34" charset="0"/>
              </a:rPr>
              <a:t>was</a:t>
            </a:r>
            <a:r>
              <a:rPr lang="tr-TR" sz="1600" dirty="0">
                <a:effectLst/>
                <a:ea typeface="Calibri" panose="020F0502020204030204" pitchFamily="34" charset="0"/>
              </a:rPr>
              <a:t> 9.37 </a:t>
            </a:r>
          </a:p>
          <a:p>
            <a:r>
              <a:rPr lang="tr-TR" sz="1600" dirty="0">
                <a:ea typeface="Calibri" panose="020F0502020204030204" pitchFamily="34" charset="0"/>
              </a:rPr>
              <a:t>                </a:t>
            </a:r>
            <a:r>
              <a:rPr lang="tr-TR" sz="1600" dirty="0" err="1">
                <a:effectLst/>
                <a:ea typeface="Calibri" panose="020F0502020204030204" pitchFamily="34" charset="0"/>
              </a:rPr>
              <a:t>years</a:t>
            </a:r>
            <a:r>
              <a:rPr lang="tr-TR" sz="1600" dirty="0">
                <a:effectLst/>
                <a:ea typeface="Calibri" panose="020F0502020204030204" pitchFamily="34" charset="0"/>
              </a:rPr>
              <a:t> (25th–75th </a:t>
            </a:r>
            <a:r>
              <a:rPr lang="tr-TR" sz="1600" dirty="0" err="1">
                <a:effectLst/>
                <a:ea typeface="Calibri" panose="020F0502020204030204" pitchFamily="34" charset="0"/>
              </a:rPr>
              <a:t>percentile</a:t>
            </a:r>
            <a:r>
              <a:rPr lang="tr-TR" sz="1600" dirty="0">
                <a:effectLst/>
                <a:ea typeface="Calibri" panose="020F0502020204030204" pitchFamily="34" charset="0"/>
              </a:rPr>
              <a:t>: 4.28-13.08). </a:t>
            </a:r>
          </a:p>
          <a:p>
            <a:endParaRPr lang="tr-TR" sz="1600" spc="10" dirty="0">
              <a:solidFill>
                <a:srgbClr val="000000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tr-TR" sz="1600" spc="1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               25.8 </a:t>
            </a:r>
            <a:r>
              <a:rPr lang="tr-TR" sz="1600" spc="10" dirty="0" err="1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per</a:t>
            </a:r>
            <a:r>
              <a:rPr lang="tr-TR" sz="1600" spc="1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1000 </a:t>
            </a:r>
            <a:r>
              <a:rPr lang="tr-TR" sz="1600" spc="10" dirty="0" err="1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patient-years</a:t>
            </a:r>
            <a:endParaRPr lang="tr-TR" sz="1600" spc="10" dirty="0">
              <a:solidFill>
                <a:srgbClr val="000000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03CB0968-F001-DA0B-2A62-2AE910F4248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24245492"/>
              </p:ext>
            </p:extLst>
          </p:nvPr>
        </p:nvGraphicFramePr>
        <p:xfrm>
          <a:off x="2476939" y="3773663"/>
          <a:ext cx="3725817" cy="1402461"/>
        </p:xfrm>
        <a:graphic>
          <a:graphicData uri="http://schemas.openxmlformats.org/drawingml/2006/table">
            <a:tbl>
              <a:tblPr firstRow="1" firstCol="1" bandRow="1"/>
              <a:tblGrid>
                <a:gridCol w="1469005">
                  <a:extLst>
                    <a:ext uri="{9D8B030D-6E8A-4147-A177-3AD203B41FA5}">
                      <a16:colId xmlns:a16="http://schemas.microsoft.com/office/drawing/2014/main" val="1904563907"/>
                    </a:ext>
                  </a:extLst>
                </a:gridCol>
                <a:gridCol w="1275860">
                  <a:extLst>
                    <a:ext uri="{9D8B030D-6E8A-4147-A177-3AD203B41FA5}">
                      <a16:colId xmlns:a16="http://schemas.microsoft.com/office/drawing/2014/main" val="1430620498"/>
                    </a:ext>
                  </a:extLst>
                </a:gridCol>
                <a:gridCol w="980952">
                  <a:extLst>
                    <a:ext uri="{9D8B030D-6E8A-4147-A177-3AD203B41FA5}">
                      <a16:colId xmlns:a16="http://schemas.microsoft.com/office/drawing/2014/main" val="308811542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000" b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TR" sz="1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000" b="1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R (95% CI)</a:t>
                      </a:r>
                      <a:endParaRPr lang="en-T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000" b="1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lang="tr-TR" sz="1000" b="1" dirty="0" err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alue</a:t>
                      </a:r>
                      <a:endParaRPr lang="en-T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943693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000" b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emodialysis</a:t>
                      </a:r>
                      <a:endParaRPr lang="en-TR" sz="1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0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9 (1.9-4.5)</a:t>
                      </a:r>
                      <a:endParaRPr lang="en-T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000" b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en-TR" sz="1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650468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000" b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ge group</a:t>
                      </a:r>
                      <a:endParaRPr lang="en-TR" sz="1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0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TR" sz="1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000" b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TR" sz="1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22393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000">
                          <a:solidFill>
                            <a:srgbClr val="040C28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≤</a:t>
                      </a:r>
                      <a:r>
                        <a:rPr lang="tr-TR" sz="10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6 years </a:t>
                      </a:r>
                      <a:endParaRPr lang="en-TR" sz="1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0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3 (4.3-12.4)</a:t>
                      </a:r>
                      <a:endParaRPr lang="en-T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000" b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en-TR" sz="1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05232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0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6.1-12 years</a:t>
                      </a:r>
                      <a:endParaRPr lang="en-TR" sz="1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0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1 (1.3-3.2)</a:t>
                      </a:r>
                      <a:endParaRPr lang="en-T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000" b="1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T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639825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0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&gt;12 years (Ref)</a:t>
                      </a:r>
                      <a:endParaRPr lang="en-TR" sz="1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000" b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TR" sz="1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000" b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TR" sz="1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32869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000" b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eriod</a:t>
                      </a:r>
                      <a:endParaRPr lang="en-TR" sz="1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000" b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TR" sz="1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000" b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TR" sz="1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546113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0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2006-2018 </a:t>
                      </a:r>
                      <a:endParaRPr lang="en-TR" sz="1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0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5 (1.0-2.2)</a:t>
                      </a:r>
                      <a:endParaRPr lang="en-T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000" b="1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32</a:t>
                      </a:r>
                      <a:endParaRPr lang="en-T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0694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0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2019-2022 (</a:t>
                      </a:r>
                      <a:r>
                        <a:rPr lang="tr-TR" sz="1000" dirty="0" err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f</a:t>
                      </a:r>
                      <a:r>
                        <a:rPr lang="tr-TR" sz="10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T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000" b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TR" sz="1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000" b="1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TR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5904325"/>
                  </a:ext>
                </a:extLst>
              </a:tr>
            </a:tbl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CBF47FCF-FC25-120D-B8D1-8B8B5AA9EE2C}"/>
              </a:ext>
            </a:extLst>
          </p:cNvPr>
          <p:cNvSpPr txBox="1"/>
          <p:nvPr/>
        </p:nvSpPr>
        <p:spPr>
          <a:xfrm>
            <a:off x="2526233" y="5242921"/>
            <a:ext cx="3783169" cy="4143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tr-TR" sz="1000" b="1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able</a:t>
            </a:r>
            <a:r>
              <a:rPr lang="tr-TR" sz="1000" b="1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0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Effect</a:t>
            </a:r>
            <a:r>
              <a:rPr lang="tr-TR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of </a:t>
            </a:r>
            <a:r>
              <a:rPr lang="tr-TR" sz="10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dialysis</a:t>
            </a:r>
            <a:r>
              <a:rPr lang="tr-TR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0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modality</a:t>
            </a:r>
            <a:r>
              <a:rPr lang="tr-TR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on </a:t>
            </a:r>
            <a:r>
              <a:rPr lang="tr-TR" sz="10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mortality</a:t>
            </a:r>
            <a:r>
              <a:rPr lang="tr-TR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tr-TR" sz="10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ox</a:t>
            </a:r>
            <a:r>
              <a:rPr lang="tr-TR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0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proportional</a:t>
            </a:r>
            <a:r>
              <a:rPr lang="tr-TR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0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hazards</a:t>
            </a:r>
            <a:r>
              <a:rPr lang="tr-TR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model (</a:t>
            </a:r>
            <a:r>
              <a:rPr lang="tr-TR" sz="10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HR:Hazard</a:t>
            </a:r>
            <a:r>
              <a:rPr lang="tr-TR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0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ratio</a:t>
            </a:r>
            <a:r>
              <a:rPr lang="tr-TR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, CI: </a:t>
            </a:r>
            <a:r>
              <a:rPr lang="tr-TR" sz="10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onfidence</a:t>
            </a:r>
            <a:r>
              <a:rPr lang="tr-TR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0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interval</a:t>
            </a:r>
            <a:r>
              <a:rPr lang="tr-TR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endParaRPr lang="en-TR" sz="10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C02E976-1F9F-0108-1EEB-DA69DD2EDD84}"/>
              </a:ext>
            </a:extLst>
          </p:cNvPr>
          <p:cNvSpPr txBox="1"/>
          <p:nvPr/>
        </p:nvSpPr>
        <p:spPr>
          <a:xfrm>
            <a:off x="7086701" y="5239942"/>
            <a:ext cx="4762394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tr-TR" sz="1000" b="1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Figure</a:t>
            </a:r>
            <a:r>
              <a:rPr lang="tr-TR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0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djusted</a:t>
            </a:r>
            <a:r>
              <a:rPr lang="tr-TR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Kaplan–</a:t>
            </a:r>
            <a:r>
              <a:rPr lang="tr-TR" sz="10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Meier</a:t>
            </a:r>
            <a:r>
              <a:rPr lang="tr-TR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0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urvival</a:t>
            </a:r>
            <a:r>
              <a:rPr lang="tr-TR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0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urves</a:t>
            </a:r>
            <a:r>
              <a:rPr lang="tr-TR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0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o</a:t>
            </a:r>
            <a:r>
              <a:rPr lang="tr-TR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0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ompare</a:t>
            </a:r>
            <a:r>
              <a:rPr lang="tr-TR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0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peritoneal</a:t>
            </a:r>
            <a:r>
              <a:rPr lang="tr-TR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0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dialysis</a:t>
            </a:r>
            <a:r>
              <a:rPr lang="tr-TR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(PD) </a:t>
            </a:r>
            <a:r>
              <a:rPr lang="tr-TR" sz="10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nd</a:t>
            </a:r>
            <a:r>
              <a:rPr lang="tr-TR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0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hemodialysis</a:t>
            </a:r>
            <a:r>
              <a:rPr lang="tr-TR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(HD) in </a:t>
            </a:r>
            <a:r>
              <a:rPr lang="tr-TR" sz="10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hildren</a:t>
            </a:r>
            <a:r>
              <a:rPr lang="tr-TR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endParaRPr lang="en-GB" sz="1000" dirty="0"/>
          </a:p>
        </p:txBody>
      </p:sp>
      <p:sp>
        <p:nvSpPr>
          <p:cNvPr id="20" name="Freeform: Shape 46">
            <a:extLst>
              <a:ext uri="{FF2B5EF4-FFF2-40B4-BE49-F238E27FC236}">
                <a16:creationId xmlns:a16="http://schemas.microsoft.com/office/drawing/2014/main" id="{DCBDD421-3CE1-1CF3-6A3A-92830484F826}"/>
              </a:ext>
            </a:extLst>
          </p:cNvPr>
          <p:cNvSpPr/>
          <p:nvPr/>
        </p:nvSpPr>
        <p:spPr>
          <a:xfrm>
            <a:off x="2618558" y="2125763"/>
            <a:ext cx="242429" cy="412737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pic>
        <p:nvPicPr>
          <p:cNvPr id="32" name="Picture 31">
            <a:extLst>
              <a:ext uri="{FF2B5EF4-FFF2-40B4-BE49-F238E27FC236}">
                <a16:creationId xmlns:a16="http://schemas.microsoft.com/office/drawing/2014/main" id="{2DDDD116-C368-6066-AC4E-BFB093E593D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11599" y="2693793"/>
            <a:ext cx="249388" cy="347508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34DD80C1-110B-7AC7-8E75-D4AB9EEBA5C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26233" y="3100229"/>
            <a:ext cx="454162" cy="457092"/>
          </a:xfrm>
          <a:prstGeom prst="rect">
            <a:avLst/>
          </a:prstGeom>
        </p:spPr>
      </p:pic>
      <p:pic>
        <p:nvPicPr>
          <p:cNvPr id="4" name="Resim 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86701" y="1776720"/>
            <a:ext cx="4468058" cy="3429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01</TotalTime>
  <Words>255</Words>
  <Application>Microsoft Office PowerPoint</Application>
  <PresentationFormat>Widescreen</PresentationFormat>
  <Paragraphs>4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eciliaLTPro-75Bold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Joseph Laycock</cp:lastModifiedBy>
  <cp:revision>67</cp:revision>
  <dcterms:created xsi:type="dcterms:W3CDTF">2019-06-13T12:30:18Z</dcterms:created>
  <dcterms:modified xsi:type="dcterms:W3CDTF">2026-03-09T16:08:15Z</dcterms:modified>
</cp:coreProperties>
</file>